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F7F7"/>
    <a:srgbClr val="FDFDFD"/>
    <a:srgbClr val="FF505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4553" autoAdjust="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1884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43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966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188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249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731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454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8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028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404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662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031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84B3-44C0-424E-B9E1-4A102FEB35D4}" type="datetimeFigureOut">
              <a:rPr lang="en-US" smtClean="0"/>
              <a:t>12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688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1507246"/>
              </p:ext>
            </p:extLst>
          </p:nvPr>
        </p:nvGraphicFramePr>
        <p:xfrm>
          <a:off x="466202" y="263645"/>
          <a:ext cx="5923964" cy="31174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79826"/>
                <a:gridCol w="637953"/>
                <a:gridCol w="1298493"/>
                <a:gridCol w="1604196"/>
                <a:gridCol w="777568"/>
                <a:gridCol w="625928"/>
              </a:tblGrid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notatio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_primer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5'-&gt;3'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_primer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5'-&gt;3'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points 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t curve </a:t>
                      </a: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s (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points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01g39540.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F/AP2</a:t>
                      </a:r>
                      <a:r>
                        <a:rPr lang="en-US" sz="8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GGCGGAAATTAGGA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CCCTCCACCTT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01g39540.N2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F/AP2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AAACTCAACTGGATG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CTATACACTGTCCAAAATG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d (shouldering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03g32747.N9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L5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AAGCATATGACCATGGA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ATTTCCACAGAAGATGTATT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06g15341.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F/AP2</a:t>
                      </a:r>
                      <a:r>
                        <a:rPr lang="en-US" sz="8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GGAGAGGTGCCAAT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GAAGGCATGGTTGGT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06g15341.N2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F/AP2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CGAAACCCATCCTTG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AATAAAAGTTGCTCATCTC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15g10070.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2 oxidase sense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AGAAAAAGATGAAAAATCACA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CTCACTGTCCCCT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15g10070.N2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2 oxidase antisense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GGTTTCGTCCACAA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TGACGTGTCGCTA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45,D5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17g00950.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L 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ACACGTTGTTCCCAAAA 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CGGTAGCCGTGAA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15,4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17g00950.N2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L antisen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CCTCCAAAGCACCAG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TGTGAGGTGTCTCTTC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D15,45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9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ma14g00360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aptic vesicle protein EHS-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GCAACCTGGTATCCAAGAA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CCACGTTCACAGCTTTC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15" marR="6315" marT="63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8174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5</TotalTime>
  <Words>100</Words>
  <Application>Microsoft Office PowerPoint</Application>
  <PresentationFormat>Letter Paper (8.5x11 in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irginia Te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asa Aghamirzaie</dc:creator>
  <cp:lastModifiedBy>Eva</cp:lastModifiedBy>
  <cp:revision>24</cp:revision>
  <cp:lastPrinted>2014-12-05T22:43:46Z</cp:lastPrinted>
  <dcterms:created xsi:type="dcterms:W3CDTF">2014-12-05T21:51:48Z</dcterms:created>
  <dcterms:modified xsi:type="dcterms:W3CDTF">2014-12-19T19:28:59Z</dcterms:modified>
</cp:coreProperties>
</file>